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A3FD8-A267-4E83-8AEB-B33E6109D5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3709D-7A3C-49DF-80F1-4D7864F2D1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1A816-7023-4DBC-80C3-28A8C0B0FB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579DD-EE02-4577-A4B1-0E075F9A5C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E970D-E573-43A0-848A-34CC3930D7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5636E-E386-478A-84BE-C0ACF3BC41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59F51-9288-472C-87CF-60D7534D83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0F259-4CD4-4D5C-9012-0B8F2F3D16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75BBE-F496-4CD3-A18A-F3026E0ED4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79782-0EF8-4DC9-9E33-E6D7E55CA6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06FE6-82DD-461F-9B70-F3DF2939B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B313A-7946-4864-BC5C-83A75C1D06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E7B14A-92A6-45AA-8806-004C529A232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403280" y="1341360"/>
          <a:ext cx="6096240" cy="26067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03280" y="1341360"/>
                    <a:ext cx="6096240" cy="2606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332000" y="4076640"/>
            <a:ext cx="6624720" cy="250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. Elution profiles of purified YedY on gel filtration chromatograph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el filtration was performed using a Superdex 200 10/30 column (Amersham Biosciences). The three enzymes were purified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. sphaeroid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arboring either the plasmid pSM88 for the “C-ter tag” YedY or plasmid pSM196 for “N Ter tag” YedY. The enzyme “No tag” results from the cleavage with TEV protease of the “N-ter tag” enzyme. 0.5 to 1 mg of pure YedY were loaded onto the column. Calibration with standards (Amersham Biosciences) produced the calibration curve Log (MW) = -0.224 * Vol (ml) + 7.77. As a result, the three enzymes are monomeric with an elution volume around 15 ml. A small peak at 13.5 ml could represent dimers. For the N-ter tag enzyme, a peak is visible at 6.4 ml that corresponds to the void volume, and is probably due to protein aggregat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5T10:56:04Z</dcterms:created>
  <dc:creator>CEA</dc:creator>
  <dc:description/>
  <dc:language>en-US</dc:language>
  <cp:lastModifiedBy>CEA</cp:lastModifiedBy>
  <dcterms:modified xsi:type="dcterms:W3CDTF">2013-09-19T11:45:45Z</dcterms:modified>
  <cp:revision>2</cp:revision>
  <dc:subject/>
  <dc:title>Diapositive 1</dc:title>
</cp:coreProperties>
</file>